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jpeg" ContentType="image/jpeg"/>
  <Override PartName="/ppt/media/image2.jpeg" ContentType="image/jpeg"/>
  <Override PartName="/ppt/media/image3.jpeg" ContentType="image/jpe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504363" cy="7578725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3BC2815-F3DF-46CB-A709-48B6DA4E886A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74840" y="303120"/>
            <a:ext cx="8555040" cy="1263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74840" y="1767960"/>
            <a:ext cx="8555040" cy="2385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74840" y="4380840"/>
            <a:ext cx="8555040" cy="2385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2AE3355-5B8E-4C25-9D7E-1F36DDB0BCBA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74840" y="303120"/>
            <a:ext cx="8555040" cy="1263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74840" y="1767960"/>
            <a:ext cx="4174560" cy="2385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858560" y="1767960"/>
            <a:ext cx="4174560" cy="2385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74840" y="4380840"/>
            <a:ext cx="4174560" cy="2385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858560" y="4380840"/>
            <a:ext cx="4174560" cy="2385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0E90A54-1C39-4D99-822D-AEF8CB12A98A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74840" y="303120"/>
            <a:ext cx="8555040" cy="1263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74840" y="1767960"/>
            <a:ext cx="2754360" cy="2385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367440" y="1767960"/>
            <a:ext cx="2754360" cy="2385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259680" y="1767960"/>
            <a:ext cx="2754360" cy="2385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74840" y="4380840"/>
            <a:ext cx="2754360" cy="2385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367440" y="4380840"/>
            <a:ext cx="2754360" cy="2385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259680" y="4380840"/>
            <a:ext cx="2754360" cy="2385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8B2F9F5-E764-4E73-AF11-EDEF5693457B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74840" y="303120"/>
            <a:ext cx="8555040" cy="1263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74840" y="1767960"/>
            <a:ext cx="8555040" cy="50022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E6469F2-7340-489A-90DB-13BD0B52B482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74840" y="303120"/>
            <a:ext cx="8555040" cy="1263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74840" y="1767960"/>
            <a:ext cx="8555040" cy="5002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699D4C0-433E-404E-998B-20F15C434FDB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74840" y="303120"/>
            <a:ext cx="8555040" cy="1263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74840" y="1767960"/>
            <a:ext cx="4174560" cy="5002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858560" y="1767960"/>
            <a:ext cx="4174560" cy="5002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81C4CE2-3EEC-439B-A559-0C273A5074C1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74840" y="303120"/>
            <a:ext cx="8555040" cy="1263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7516E87-78C1-4A4D-B304-8DE22CABE8D0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74840" y="303120"/>
            <a:ext cx="8555040" cy="58586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E42794B-C568-4B77-BF7D-3A3F0014E444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74840" y="303120"/>
            <a:ext cx="8555040" cy="1263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74840" y="1767960"/>
            <a:ext cx="4174560" cy="2385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858560" y="1767960"/>
            <a:ext cx="4174560" cy="5002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74840" y="4380840"/>
            <a:ext cx="4174560" cy="2385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2D9BEA0-3FDD-41BC-A1E6-0C2D7AA83E4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74840" y="303120"/>
            <a:ext cx="8555040" cy="1263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74840" y="1767960"/>
            <a:ext cx="4174560" cy="5002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858560" y="1767960"/>
            <a:ext cx="4174560" cy="2385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858560" y="4380840"/>
            <a:ext cx="4174560" cy="2385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6BF5368-2A8B-4338-A7CF-7DFCB1695B6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74840" y="303120"/>
            <a:ext cx="8555040" cy="1263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74840" y="1767960"/>
            <a:ext cx="4174560" cy="2385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858560" y="1767960"/>
            <a:ext cx="4174560" cy="2385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74840" y="4380840"/>
            <a:ext cx="8555040" cy="2385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5A1F63D-ABA1-45C7-B8E9-12254BC4C70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74840" y="303120"/>
            <a:ext cx="8555040" cy="1263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74840" y="1767960"/>
            <a:ext cx="8555040" cy="5002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74840" y="7023240"/>
            <a:ext cx="2217600" cy="403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zh-TW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A1529903-CE2B-4726-9B36-87F8470A07B0}" type="datetime">
              <a:rPr b="0" lang="zh-TW" sz="1200" spc="-1" strike="noStrike">
                <a:solidFill>
                  <a:srgbClr val="898989"/>
                </a:solidFill>
                <a:latin typeface="Calibri"/>
              </a:rPr>
              <a:t>115/08/29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247560" y="7023240"/>
            <a:ext cx="3008520" cy="403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811560" y="7023240"/>
            <a:ext cx="2217960" cy="403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zh-TW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A737C325-6E66-447E-8E46-B15432263DC3}" type="slidenum">
              <a:rPr b="0" lang="zh-TW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image" Target="../media/image2.jpeg"/><Relationship Id="rId3" Type="http://schemas.openxmlformats.org/officeDocument/2006/relationships/image" Target="../media/image3.jpeg"/><Relationship Id="rId4" Type="http://schemas.openxmlformats.org/officeDocument/2006/relationships/slideLayout" Target="../slideLayouts/slideLayout3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Picture 5" descr="IMG_2574"/>
          <p:cNvPicPr/>
          <p:nvPr/>
        </p:nvPicPr>
        <p:blipFill>
          <a:blip r:embed="rId1"/>
          <a:stretch/>
        </p:blipFill>
        <p:spPr>
          <a:xfrm>
            <a:off x="317520" y="1380960"/>
            <a:ext cx="2957400" cy="2367000"/>
          </a:xfrm>
          <a:prstGeom prst="rect">
            <a:avLst/>
          </a:prstGeom>
          <a:ln w="0">
            <a:noFill/>
          </a:ln>
        </p:spPr>
      </p:pic>
      <p:pic>
        <p:nvPicPr>
          <p:cNvPr id="42" name="Picture 6" descr="IMG_2567"/>
          <p:cNvPicPr/>
          <p:nvPr/>
        </p:nvPicPr>
        <p:blipFill>
          <a:blip r:embed="rId2"/>
          <a:stretch/>
        </p:blipFill>
        <p:spPr>
          <a:xfrm>
            <a:off x="6288120" y="1380960"/>
            <a:ext cx="2959200" cy="2367000"/>
          </a:xfrm>
          <a:prstGeom prst="rect">
            <a:avLst/>
          </a:prstGeom>
          <a:ln w="0">
            <a:noFill/>
          </a:ln>
        </p:spPr>
      </p:pic>
      <p:pic>
        <p:nvPicPr>
          <p:cNvPr id="43" name="Picture 7" descr="IMG_2573"/>
          <p:cNvPicPr/>
          <p:nvPr/>
        </p:nvPicPr>
        <p:blipFill>
          <a:blip r:embed="rId3"/>
          <a:stretch/>
        </p:blipFill>
        <p:spPr>
          <a:xfrm>
            <a:off x="3301920" y="1382760"/>
            <a:ext cx="2960640" cy="2365200"/>
          </a:xfrm>
          <a:prstGeom prst="rect">
            <a:avLst/>
          </a:prstGeom>
          <a:ln w="0">
            <a:noFill/>
          </a:ln>
        </p:spPr>
      </p:pic>
      <p:sp>
        <p:nvSpPr>
          <p:cNvPr id="44" name=""/>
          <p:cNvSpPr/>
          <p:nvPr/>
        </p:nvSpPr>
        <p:spPr>
          <a:xfrm>
            <a:off x="317520" y="1382760"/>
            <a:ext cx="5792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A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" name=""/>
          <p:cNvSpPr/>
          <p:nvPr/>
        </p:nvSpPr>
        <p:spPr>
          <a:xfrm>
            <a:off x="6288120" y="1382760"/>
            <a:ext cx="5810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1125"/>
              </a:spcBef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C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"/>
          <p:cNvSpPr/>
          <p:nvPr/>
        </p:nvSpPr>
        <p:spPr>
          <a:xfrm>
            <a:off x="3301920" y="1382760"/>
            <a:ext cx="5810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1125"/>
              </a:spcBef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B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7" name=""/>
          <p:cNvSpPr/>
          <p:nvPr/>
        </p:nvSpPr>
        <p:spPr>
          <a:xfrm>
            <a:off x="317520" y="3916440"/>
            <a:ext cx="892980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just">
              <a:lnSpc>
                <a:spcPct val="100000"/>
              </a:lnSpc>
              <a:spcBef>
                <a:spcPts val="751"/>
              </a:spcBef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Figure S1. Severe edema was developed in mouse uteri after 4 weeks of E2 exposure. (A) The uterus of Balb/c mouse showed no significant change in size. (B) C57BL/6 and (C) C3H/He mouse uteri were filled with fluids.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8" name=""/>
          <p:cNvSpPr/>
          <p:nvPr/>
        </p:nvSpPr>
        <p:spPr>
          <a:xfrm>
            <a:off x="349200" y="3429000"/>
            <a:ext cx="10969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876"/>
              </a:spcBef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Balb/c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9" name=""/>
          <p:cNvSpPr/>
          <p:nvPr/>
        </p:nvSpPr>
        <p:spPr>
          <a:xfrm>
            <a:off x="3274920" y="3429000"/>
            <a:ext cx="10954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876"/>
              </a:spcBef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C57BL/6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0" name=""/>
          <p:cNvSpPr/>
          <p:nvPr/>
        </p:nvSpPr>
        <p:spPr>
          <a:xfrm>
            <a:off x="6262560" y="3429000"/>
            <a:ext cx="10954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876"/>
              </a:spcBef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C3H/He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03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4-08-20T00:05:59Z</dcterms:created>
  <dc:creator>u0557754</dc:creator>
  <dc:description/>
  <dc:language>en-US</dc:language>
  <cp:lastModifiedBy>CROFT</cp:lastModifiedBy>
  <dcterms:modified xsi:type="dcterms:W3CDTF">2014-11-26T22:56:56Z</dcterms:modified>
  <cp:revision>10</cp:revision>
  <dc:subject/>
  <dc:title>Slide 1</dc:title>
</cp:coreProperties>
</file>